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19" autoAdjust="0"/>
    <p:restoredTop sz="94709" autoAdjust="0"/>
  </p:normalViewPr>
  <p:slideViewPr>
    <p:cSldViewPr>
      <p:cViewPr>
        <p:scale>
          <a:sx n="50" d="100"/>
          <a:sy n="50" d="100"/>
        </p:scale>
        <p:origin x="-2010" y="-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dr%20soma%20sarkar\Desktop\OCI_RESULT_MAY2010\PE%20vs%20CN\New%20Microsoft%20Office%20Excel%20Workshee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dr%20soma%20sarkar\Desktop\MS_geneexpression\%25%20differentially%20expressed%20genes%20PE_CN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plotArea>
      <c:layout>
        <c:manualLayout>
          <c:layoutTarget val="inner"/>
          <c:xMode val="edge"/>
          <c:yMode val="edge"/>
          <c:x val="0.40182641628326526"/>
          <c:y val="0"/>
          <c:w val="0.43959724322249732"/>
          <c:h val="0.938277115360581"/>
        </c:manualLayout>
      </c:layout>
      <c:barChart>
        <c:barDir val="bar"/>
        <c:grouping val="clustered"/>
        <c:ser>
          <c:idx val="0"/>
          <c:order val="0"/>
          <c:tx>
            <c:strRef>
              <c:f>Sheet2!$H$1</c:f>
              <c:strCache>
                <c:ptCount val="1"/>
                <c:pt idx="0">
                  <c:v># Genes_Up</c:v>
                </c:pt>
              </c:strCache>
            </c:strRef>
          </c:tx>
          <c:cat>
            <c:strRef>
              <c:f>Sheet2!$G$2:$G$32</c:f>
              <c:strCache>
                <c:ptCount val="31"/>
                <c:pt idx="0">
                  <c:v>others</c:v>
                </c:pt>
                <c:pt idx="1">
                  <c:v>Biological adhesion</c:v>
                </c:pt>
                <c:pt idx="2">
                  <c:v>Biological regulation</c:v>
                </c:pt>
                <c:pt idx="3">
                  <c:v>Cellular process</c:v>
                </c:pt>
                <c:pt idx="4">
                  <c:v>Response to stimulus</c:v>
                </c:pt>
                <c:pt idx="5">
                  <c:v>Developmental process</c:v>
                </c:pt>
                <c:pt idx="6">
                  <c:v>Localization</c:v>
                </c:pt>
                <c:pt idx="7">
                  <c:v>Metabolic process</c:v>
                </c:pt>
                <c:pt idx="8">
                  <c:v>Multicellular organismal process</c:v>
                </c:pt>
                <c:pt idx="9">
                  <c:v>Negative regulation of biological process</c:v>
                </c:pt>
                <c:pt idx="10">
                  <c:v>Positive regulation of biological process</c:v>
                </c:pt>
                <c:pt idx="11">
                  <c:v>Regulation of biological process</c:v>
                </c:pt>
                <c:pt idx="12">
                  <c:v>Establishment of localization</c:v>
                </c:pt>
                <c:pt idx="15">
                  <c:v>others</c:v>
                </c:pt>
                <c:pt idx="16">
                  <c:v>Enzyme regulator activity</c:v>
                </c:pt>
                <c:pt idx="17">
                  <c:v>Transcription regulator activity</c:v>
                </c:pt>
                <c:pt idx="18">
                  <c:v>Catalytic activity</c:v>
                </c:pt>
                <c:pt idx="19">
                  <c:v>Molecular transducer activity</c:v>
                </c:pt>
                <c:pt idx="20">
                  <c:v>Transporter activity</c:v>
                </c:pt>
                <c:pt idx="21">
                  <c:v>Binding</c:v>
                </c:pt>
                <c:pt idx="24">
                  <c:v>others</c:v>
                </c:pt>
                <c:pt idx="25">
                  <c:v>Membrane-enclosed lumen</c:v>
                </c:pt>
                <c:pt idx="26">
                  <c:v>Macromolecular complex</c:v>
                </c:pt>
                <c:pt idx="27">
                  <c:v>Organelle part</c:v>
                </c:pt>
                <c:pt idx="28">
                  <c:v>Cell part</c:v>
                </c:pt>
                <c:pt idx="29">
                  <c:v>Extracellular region</c:v>
                </c:pt>
                <c:pt idx="30">
                  <c:v>Cell</c:v>
                </c:pt>
              </c:strCache>
            </c:strRef>
          </c:cat>
          <c:val>
            <c:numRef>
              <c:f>Sheet2!$H$2:$H$32</c:f>
            </c:numRef>
          </c:val>
        </c:ser>
        <c:ser>
          <c:idx val="1"/>
          <c:order val="1"/>
          <c:tx>
            <c:strRef>
              <c:f>Sheet2!$I$1</c:f>
              <c:strCache>
                <c:ptCount val="1"/>
                <c:pt idx="0">
                  <c:v># Genes_Down</c:v>
                </c:pt>
              </c:strCache>
            </c:strRef>
          </c:tx>
          <c:cat>
            <c:strRef>
              <c:f>Sheet2!$G$2:$G$32</c:f>
              <c:strCache>
                <c:ptCount val="31"/>
                <c:pt idx="0">
                  <c:v>others</c:v>
                </c:pt>
                <c:pt idx="1">
                  <c:v>Biological adhesion</c:v>
                </c:pt>
                <c:pt idx="2">
                  <c:v>Biological regulation</c:v>
                </c:pt>
                <c:pt idx="3">
                  <c:v>Cellular process</c:v>
                </c:pt>
                <c:pt idx="4">
                  <c:v>Response to stimulus</c:v>
                </c:pt>
                <c:pt idx="5">
                  <c:v>Developmental process</c:v>
                </c:pt>
                <c:pt idx="6">
                  <c:v>Localization</c:v>
                </c:pt>
                <c:pt idx="7">
                  <c:v>Metabolic process</c:v>
                </c:pt>
                <c:pt idx="8">
                  <c:v>Multicellular organismal process</c:v>
                </c:pt>
                <c:pt idx="9">
                  <c:v>Negative regulation of biological process</c:v>
                </c:pt>
                <c:pt idx="10">
                  <c:v>Positive regulation of biological process</c:v>
                </c:pt>
                <c:pt idx="11">
                  <c:v>Regulation of biological process</c:v>
                </c:pt>
                <c:pt idx="12">
                  <c:v>Establishment of localization</c:v>
                </c:pt>
                <c:pt idx="15">
                  <c:v>others</c:v>
                </c:pt>
                <c:pt idx="16">
                  <c:v>Enzyme regulator activity</c:v>
                </c:pt>
                <c:pt idx="17">
                  <c:v>Transcription regulator activity</c:v>
                </c:pt>
                <c:pt idx="18">
                  <c:v>Catalytic activity</c:v>
                </c:pt>
                <c:pt idx="19">
                  <c:v>Molecular transducer activity</c:v>
                </c:pt>
                <c:pt idx="20">
                  <c:v>Transporter activity</c:v>
                </c:pt>
                <c:pt idx="21">
                  <c:v>Binding</c:v>
                </c:pt>
                <c:pt idx="24">
                  <c:v>others</c:v>
                </c:pt>
                <c:pt idx="25">
                  <c:v>Membrane-enclosed lumen</c:v>
                </c:pt>
                <c:pt idx="26">
                  <c:v>Macromolecular complex</c:v>
                </c:pt>
                <c:pt idx="27">
                  <c:v>Organelle part</c:v>
                </c:pt>
                <c:pt idx="28">
                  <c:v>Cell part</c:v>
                </c:pt>
                <c:pt idx="29">
                  <c:v>Extracellular region</c:v>
                </c:pt>
                <c:pt idx="30">
                  <c:v>Cell</c:v>
                </c:pt>
              </c:strCache>
            </c:strRef>
          </c:cat>
          <c:val>
            <c:numRef>
              <c:f>Sheet2!$I$2:$I$32</c:f>
            </c:numRef>
          </c:val>
        </c:ser>
        <c:ser>
          <c:idx val="2"/>
          <c:order val="2"/>
          <c:tx>
            <c:strRef>
              <c:f>Sheet2!$J$1</c:f>
              <c:strCache>
                <c:ptCount val="1"/>
                <c:pt idx="0">
                  <c:v>% Genes_Up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2!$G$2:$G$32</c:f>
              <c:strCache>
                <c:ptCount val="31"/>
                <c:pt idx="0">
                  <c:v>others</c:v>
                </c:pt>
                <c:pt idx="1">
                  <c:v>Biological adhesion</c:v>
                </c:pt>
                <c:pt idx="2">
                  <c:v>Biological regulation</c:v>
                </c:pt>
                <c:pt idx="3">
                  <c:v>Cellular process</c:v>
                </c:pt>
                <c:pt idx="4">
                  <c:v>Response to stimulus</c:v>
                </c:pt>
                <c:pt idx="5">
                  <c:v>Developmental process</c:v>
                </c:pt>
                <c:pt idx="6">
                  <c:v>Localization</c:v>
                </c:pt>
                <c:pt idx="7">
                  <c:v>Metabolic process</c:v>
                </c:pt>
                <c:pt idx="8">
                  <c:v>Multicellular organismal process</c:v>
                </c:pt>
                <c:pt idx="9">
                  <c:v>Negative regulation of biological process</c:v>
                </c:pt>
                <c:pt idx="10">
                  <c:v>Positive regulation of biological process</c:v>
                </c:pt>
                <c:pt idx="11">
                  <c:v>Regulation of biological process</c:v>
                </c:pt>
                <c:pt idx="12">
                  <c:v>Establishment of localization</c:v>
                </c:pt>
                <c:pt idx="15">
                  <c:v>others</c:v>
                </c:pt>
                <c:pt idx="16">
                  <c:v>Enzyme regulator activity</c:v>
                </c:pt>
                <c:pt idx="17">
                  <c:v>Transcription regulator activity</c:v>
                </c:pt>
                <c:pt idx="18">
                  <c:v>Catalytic activity</c:v>
                </c:pt>
                <c:pt idx="19">
                  <c:v>Molecular transducer activity</c:v>
                </c:pt>
                <c:pt idx="20">
                  <c:v>Transporter activity</c:v>
                </c:pt>
                <c:pt idx="21">
                  <c:v>Binding</c:v>
                </c:pt>
                <c:pt idx="24">
                  <c:v>others</c:v>
                </c:pt>
                <c:pt idx="25">
                  <c:v>Membrane-enclosed lumen</c:v>
                </c:pt>
                <c:pt idx="26">
                  <c:v>Macromolecular complex</c:v>
                </c:pt>
                <c:pt idx="27">
                  <c:v>Organelle part</c:v>
                </c:pt>
                <c:pt idx="28">
                  <c:v>Cell part</c:v>
                </c:pt>
                <c:pt idx="29">
                  <c:v>Extracellular region</c:v>
                </c:pt>
                <c:pt idx="30">
                  <c:v>Cell</c:v>
                </c:pt>
              </c:strCache>
            </c:strRef>
          </c:cat>
          <c:val>
            <c:numRef>
              <c:f>Sheet2!$J$2:$J$32</c:f>
              <c:numCache>
                <c:formatCode>General</c:formatCode>
                <c:ptCount val="31"/>
                <c:pt idx="0">
                  <c:v>5.58</c:v>
                </c:pt>
                <c:pt idx="1">
                  <c:v>1.300108342361864</c:v>
                </c:pt>
                <c:pt idx="2">
                  <c:v>12.080173347778981</c:v>
                </c:pt>
                <c:pt idx="3">
                  <c:v>28.385698808234022</c:v>
                </c:pt>
                <c:pt idx="4">
                  <c:v>5.5796316359696796</c:v>
                </c:pt>
                <c:pt idx="5">
                  <c:v>9.5882990249187436</c:v>
                </c:pt>
                <c:pt idx="6">
                  <c:v>7.2047670639219925</c:v>
                </c:pt>
                <c:pt idx="7">
                  <c:v>8.2881906825568521</c:v>
                </c:pt>
                <c:pt idx="8">
                  <c:v>5.1462621885157134</c:v>
                </c:pt>
                <c:pt idx="9">
                  <c:v>3.0335861321776814</c:v>
                </c:pt>
                <c:pt idx="10">
                  <c:v>5.5796316359696796</c:v>
                </c:pt>
                <c:pt idx="11">
                  <c:v>4.929577464788732</c:v>
                </c:pt>
                <c:pt idx="12">
                  <c:v>3.3044420368364027</c:v>
                </c:pt>
                <c:pt idx="15">
                  <c:v>4.29</c:v>
                </c:pt>
                <c:pt idx="16">
                  <c:v>2.301255230125518</c:v>
                </c:pt>
                <c:pt idx="17">
                  <c:v>3.6610878661087871</c:v>
                </c:pt>
                <c:pt idx="18">
                  <c:v>23.117154811715526</c:v>
                </c:pt>
                <c:pt idx="19">
                  <c:v>5.7531380753138084</c:v>
                </c:pt>
                <c:pt idx="20">
                  <c:v>4.3933054393305415</c:v>
                </c:pt>
                <c:pt idx="21">
                  <c:v>56.485355648535645</c:v>
                </c:pt>
                <c:pt idx="24">
                  <c:v>4.99</c:v>
                </c:pt>
                <c:pt idx="25">
                  <c:v>3.1042128603104215</c:v>
                </c:pt>
                <c:pt idx="26">
                  <c:v>2.9933481152993338</c:v>
                </c:pt>
                <c:pt idx="27">
                  <c:v>5.7095343680709432</c:v>
                </c:pt>
                <c:pt idx="28">
                  <c:v>34.922394678492225</c:v>
                </c:pt>
                <c:pt idx="29">
                  <c:v>3.9356984478935662</c:v>
                </c:pt>
                <c:pt idx="30">
                  <c:v>44.345898004434595</c:v>
                </c:pt>
              </c:numCache>
            </c:numRef>
          </c:val>
        </c:ser>
        <c:ser>
          <c:idx val="3"/>
          <c:order val="3"/>
          <c:tx>
            <c:strRef>
              <c:f>Sheet2!$K$1</c:f>
              <c:strCache>
                <c:ptCount val="1"/>
                <c:pt idx="0">
                  <c:v>% Genes_Down</c:v>
                </c:pt>
              </c:strCache>
            </c:strRef>
          </c:tx>
          <c:spPr>
            <a:ln>
              <a:solidFill>
                <a:schemeClr val="tx1"/>
              </a:solidFill>
            </a:ln>
          </c:spPr>
          <c:cat>
            <c:strRef>
              <c:f>Sheet2!$G$2:$G$32</c:f>
              <c:strCache>
                <c:ptCount val="31"/>
                <c:pt idx="0">
                  <c:v>others</c:v>
                </c:pt>
                <c:pt idx="1">
                  <c:v>Biological adhesion</c:v>
                </c:pt>
                <c:pt idx="2">
                  <c:v>Biological regulation</c:v>
                </c:pt>
                <c:pt idx="3">
                  <c:v>Cellular process</c:v>
                </c:pt>
                <c:pt idx="4">
                  <c:v>Response to stimulus</c:v>
                </c:pt>
                <c:pt idx="5">
                  <c:v>Developmental process</c:v>
                </c:pt>
                <c:pt idx="6">
                  <c:v>Localization</c:v>
                </c:pt>
                <c:pt idx="7">
                  <c:v>Metabolic process</c:v>
                </c:pt>
                <c:pt idx="8">
                  <c:v>Multicellular organismal process</c:v>
                </c:pt>
                <c:pt idx="9">
                  <c:v>Negative regulation of biological process</c:v>
                </c:pt>
                <c:pt idx="10">
                  <c:v>Positive regulation of biological process</c:v>
                </c:pt>
                <c:pt idx="11">
                  <c:v>Regulation of biological process</c:v>
                </c:pt>
                <c:pt idx="12">
                  <c:v>Establishment of localization</c:v>
                </c:pt>
                <c:pt idx="15">
                  <c:v>others</c:v>
                </c:pt>
                <c:pt idx="16">
                  <c:v>Enzyme regulator activity</c:v>
                </c:pt>
                <c:pt idx="17">
                  <c:v>Transcription regulator activity</c:v>
                </c:pt>
                <c:pt idx="18">
                  <c:v>Catalytic activity</c:v>
                </c:pt>
                <c:pt idx="19">
                  <c:v>Molecular transducer activity</c:v>
                </c:pt>
                <c:pt idx="20">
                  <c:v>Transporter activity</c:v>
                </c:pt>
                <c:pt idx="21">
                  <c:v>Binding</c:v>
                </c:pt>
                <c:pt idx="24">
                  <c:v>others</c:v>
                </c:pt>
                <c:pt idx="25">
                  <c:v>Membrane-enclosed lumen</c:v>
                </c:pt>
                <c:pt idx="26">
                  <c:v>Macromolecular complex</c:v>
                </c:pt>
                <c:pt idx="27">
                  <c:v>Organelle part</c:v>
                </c:pt>
                <c:pt idx="28">
                  <c:v>Cell part</c:v>
                </c:pt>
                <c:pt idx="29">
                  <c:v>Extracellular region</c:v>
                </c:pt>
                <c:pt idx="30">
                  <c:v>Cell</c:v>
                </c:pt>
              </c:strCache>
            </c:strRef>
          </c:cat>
          <c:val>
            <c:numRef>
              <c:f>Sheet2!$K$2:$K$32</c:f>
              <c:numCache>
                <c:formatCode>General</c:formatCode>
                <c:ptCount val="31"/>
                <c:pt idx="0">
                  <c:v>9.2000000000000011</c:v>
                </c:pt>
                <c:pt idx="1">
                  <c:v>1.9710906701708266</c:v>
                </c:pt>
                <c:pt idx="2">
                  <c:v>10.775295663600518</c:v>
                </c:pt>
                <c:pt idx="3">
                  <c:v>27.463863337713526</c:v>
                </c:pt>
                <c:pt idx="4">
                  <c:v>9.9868593955321945</c:v>
                </c:pt>
                <c:pt idx="5">
                  <c:v>9.8554533508541589</c:v>
                </c:pt>
                <c:pt idx="6">
                  <c:v>5.6504599211563695</c:v>
                </c:pt>
                <c:pt idx="7">
                  <c:v>7.6215505913271935</c:v>
                </c:pt>
                <c:pt idx="8">
                  <c:v>3.8107752956635967</c:v>
                </c:pt>
                <c:pt idx="9">
                  <c:v>3.0223390275952693</c:v>
                </c:pt>
                <c:pt idx="10">
                  <c:v>3.9421813403416608</c:v>
                </c:pt>
                <c:pt idx="11">
                  <c:v>4.4678055190538766</c:v>
                </c:pt>
                <c:pt idx="12">
                  <c:v>2.2339027595269432</c:v>
                </c:pt>
                <c:pt idx="15">
                  <c:v>4.8899999999999997</c:v>
                </c:pt>
                <c:pt idx="16">
                  <c:v>2.0366598778004068</c:v>
                </c:pt>
                <c:pt idx="17">
                  <c:v>4.2769857433808554</c:v>
                </c:pt>
                <c:pt idx="18">
                  <c:v>18.126272912423623</c:v>
                </c:pt>
                <c:pt idx="19">
                  <c:v>4.2769857433808554</c:v>
                </c:pt>
                <c:pt idx="20">
                  <c:v>4.4806517311609024</c:v>
                </c:pt>
                <c:pt idx="21">
                  <c:v>61.91446028513225</c:v>
                </c:pt>
                <c:pt idx="24">
                  <c:v>4.49</c:v>
                </c:pt>
                <c:pt idx="25">
                  <c:v>2.0277481323372464</c:v>
                </c:pt>
                <c:pt idx="26">
                  <c:v>3.3084311632870866</c:v>
                </c:pt>
                <c:pt idx="27">
                  <c:v>5.1227321237993575</c:v>
                </c:pt>
                <c:pt idx="28">
                  <c:v>36.286019210245456</c:v>
                </c:pt>
                <c:pt idx="29">
                  <c:v>2.88153681963714</c:v>
                </c:pt>
                <c:pt idx="30">
                  <c:v>45.891141942369259</c:v>
                </c:pt>
              </c:numCache>
            </c:numRef>
          </c:val>
        </c:ser>
        <c:axId val="93058176"/>
        <c:axId val="93059712"/>
      </c:barChart>
      <c:catAx>
        <c:axId val="93058176"/>
        <c:scaling>
          <c:orientation val="minMax"/>
        </c:scaling>
        <c:axPos val="l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3059712"/>
        <c:crosses val="autoZero"/>
        <c:auto val="1"/>
        <c:lblAlgn val="ctr"/>
        <c:lblOffset val="100"/>
      </c:catAx>
      <c:valAx>
        <c:axId val="9305971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305817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04221269216348"/>
          <c:y val="0.85191983593143972"/>
          <c:w val="0.26055844581927273"/>
          <c:h val="6.1792516320075506E-2"/>
        </c:manualLayout>
      </c:layout>
      <c:txPr>
        <a:bodyPr/>
        <a:lstStyle/>
        <a:p>
          <a:pPr>
            <a:defRPr sz="10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</c:chart>
  <c:txPr>
    <a:bodyPr/>
    <a:lstStyle/>
    <a:p>
      <a:pPr>
        <a:defRPr sz="1800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style val="1"/>
  <c:chart>
    <c:plotArea>
      <c:layout>
        <c:manualLayout>
          <c:layoutTarget val="inner"/>
          <c:xMode val="edge"/>
          <c:yMode val="edge"/>
          <c:x val="0.37142544904306946"/>
          <c:y val="6.0606041324730436E-2"/>
          <c:w val="0.4504678641148514"/>
          <c:h val="0.82431978865193956"/>
        </c:manualLayout>
      </c:layout>
      <c:barChart>
        <c:barDir val="bar"/>
        <c:grouping val="clustered"/>
        <c:ser>
          <c:idx val="0"/>
          <c:order val="0"/>
          <c:tx>
            <c:strRef>
              <c:f>Sheet8!$S$1:$S$2</c:f>
              <c:strCache>
                <c:ptCount val="1"/>
                <c:pt idx="0">
                  <c:v>upregulated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cat>
            <c:strRef>
              <c:f>Sheet8!$R$3:$R$14</c:f>
              <c:strCache>
                <c:ptCount val="12"/>
                <c:pt idx="0">
                  <c:v>ATP binding</c:v>
                </c:pt>
                <c:pt idx="1">
                  <c:v>calcium ion binding</c:v>
                </c:pt>
                <c:pt idx="2">
                  <c:v>DNA binding</c:v>
                </c:pt>
                <c:pt idx="3">
                  <c:v>metal ion binding</c:v>
                </c:pt>
                <c:pt idx="4">
                  <c:v>nucleotide binding</c:v>
                </c:pt>
                <c:pt idx="5">
                  <c:v>protein binding</c:v>
                </c:pt>
                <c:pt idx="6">
                  <c:v>RNA binding</c:v>
                </c:pt>
                <c:pt idx="7">
                  <c:v>transcription factor activity</c:v>
                </c:pt>
                <c:pt idx="8">
                  <c:v>zinc ion binding</c:v>
                </c:pt>
                <c:pt idx="9">
                  <c:v>hydrolase activity</c:v>
                </c:pt>
                <c:pt idx="10">
                  <c:v>peptidase activity</c:v>
                </c:pt>
                <c:pt idx="11">
                  <c:v>transferase activity</c:v>
                </c:pt>
              </c:strCache>
            </c:strRef>
          </c:cat>
          <c:val>
            <c:numRef>
              <c:f>Sheet8!$S$3:$S$14</c:f>
              <c:numCache>
                <c:formatCode>General</c:formatCode>
                <c:ptCount val="12"/>
                <c:pt idx="0">
                  <c:v>4.8099999999999996</c:v>
                </c:pt>
                <c:pt idx="1">
                  <c:v>4.07</c:v>
                </c:pt>
                <c:pt idx="2">
                  <c:v>2.77</c:v>
                </c:pt>
                <c:pt idx="3">
                  <c:v>7.4</c:v>
                </c:pt>
                <c:pt idx="4">
                  <c:v>5.55</c:v>
                </c:pt>
                <c:pt idx="5">
                  <c:v>23.51</c:v>
                </c:pt>
                <c:pt idx="6">
                  <c:v>0.70000000000000062</c:v>
                </c:pt>
                <c:pt idx="7">
                  <c:v>3.51</c:v>
                </c:pt>
                <c:pt idx="8">
                  <c:v>6.1099999999999985</c:v>
                </c:pt>
                <c:pt idx="9">
                  <c:v>10.11</c:v>
                </c:pt>
                <c:pt idx="10">
                  <c:v>3.3699999999999997</c:v>
                </c:pt>
                <c:pt idx="11">
                  <c:v>8.98</c:v>
                </c:pt>
              </c:numCache>
            </c:numRef>
          </c:val>
        </c:ser>
        <c:ser>
          <c:idx val="1"/>
          <c:order val="1"/>
          <c:tx>
            <c:strRef>
              <c:f>Sheet8!$T$1:$T$2</c:f>
              <c:strCache>
                <c:ptCount val="1"/>
                <c:pt idx="0">
                  <c:v>downregulated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cat>
            <c:strRef>
              <c:f>Sheet8!$R$3:$R$14</c:f>
              <c:strCache>
                <c:ptCount val="12"/>
                <c:pt idx="0">
                  <c:v>ATP binding</c:v>
                </c:pt>
                <c:pt idx="1">
                  <c:v>calcium ion binding</c:v>
                </c:pt>
                <c:pt idx="2">
                  <c:v>DNA binding</c:v>
                </c:pt>
                <c:pt idx="3">
                  <c:v>metal ion binding</c:v>
                </c:pt>
                <c:pt idx="4">
                  <c:v>nucleotide binding</c:v>
                </c:pt>
                <c:pt idx="5">
                  <c:v>protein binding</c:v>
                </c:pt>
                <c:pt idx="6">
                  <c:v>RNA binding</c:v>
                </c:pt>
                <c:pt idx="7">
                  <c:v>transcription factor activity</c:v>
                </c:pt>
                <c:pt idx="8">
                  <c:v>zinc ion binding</c:v>
                </c:pt>
                <c:pt idx="9">
                  <c:v>hydrolase activity</c:v>
                </c:pt>
                <c:pt idx="10">
                  <c:v>peptidase activity</c:v>
                </c:pt>
                <c:pt idx="11">
                  <c:v>transferase activity</c:v>
                </c:pt>
              </c:strCache>
            </c:strRef>
          </c:cat>
          <c:val>
            <c:numRef>
              <c:f>Sheet8!$T$3:$T$14</c:f>
              <c:numCache>
                <c:formatCode>General</c:formatCode>
                <c:ptCount val="12"/>
                <c:pt idx="0">
                  <c:v>4.2699999999999996</c:v>
                </c:pt>
                <c:pt idx="1">
                  <c:v>2.2999999999999998</c:v>
                </c:pt>
                <c:pt idx="2">
                  <c:v>1.6400000000000001</c:v>
                </c:pt>
                <c:pt idx="3">
                  <c:v>7.56</c:v>
                </c:pt>
                <c:pt idx="4">
                  <c:v>4.9300000000000024</c:v>
                </c:pt>
                <c:pt idx="5">
                  <c:v>16.439999999999987</c:v>
                </c:pt>
                <c:pt idx="6">
                  <c:v>3.61</c:v>
                </c:pt>
                <c:pt idx="7">
                  <c:v>3.2800000000000002</c:v>
                </c:pt>
                <c:pt idx="8">
                  <c:v>6.25</c:v>
                </c:pt>
                <c:pt idx="9">
                  <c:v>7.23</c:v>
                </c:pt>
                <c:pt idx="10">
                  <c:v>5.42</c:v>
                </c:pt>
                <c:pt idx="11">
                  <c:v>10.59</c:v>
                </c:pt>
              </c:numCache>
            </c:numRef>
          </c:val>
        </c:ser>
        <c:axId val="93473024"/>
        <c:axId val="93499392"/>
      </c:barChart>
      <c:catAx>
        <c:axId val="93473024"/>
        <c:scaling>
          <c:orientation val="minMax"/>
        </c:scaling>
        <c:axPos val="l"/>
        <c:tickLblPos val="nextTo"/>
        <c:txPr>
          <a:bodyPr/>
          <a:lstStyle/>
          <a:p>
            <a:pPr>
              <a:defRPr sz="8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3499392"/>
        <c:crosses val="autoZero"/>
        <c:auto val="1"/>
        <c:lblAlgn val="ctr"/>
        <c:lblOffset val="100"/>
      </c:catAx>
      <c:valAx>
        <c:axId val="93499392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 sz="1000" b="1">
                <a:latin typeface="Arial" pitchFamily="34" charset="0"/>
                <a:cs typeface="Arial" pitchFamily="34" charset="0"/>
              </a:defRPr>
            </a:pPr>
            <a:endParaRPr lang="en-US"/>
          </a:p>
        </c:txPr>
        <c:crossAx val="934730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0921988918051939"/>
          <c:y val="0.72649268841394821"/>
          <c:w val="0.38152085156022192"/>
          <c:h val="0.10525672752444409"/>
        </c:manualLayout>
      </c:layout>
      <c:txPr>
        <a:bodyPr/>
        <a:lstStyle/>
        <a:p>
          <a:pPr>
            <a:defRPr sz="800" b="1">
              <a:latin typeface="Arial" pitchFamily="34" charset="0"/>
              <a:cs typeface="Arial" pitchFamily="34" charset="0"/>
            </a:defRPr>
          </a:pPr>
          <a:endParaRPr lang="en-US"/>
        </a:p>
      </c:txPr>
    </c:legend>
    <c:plotVisOnly val="1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575126-EF27-4AFF-9E0B-72F693DAACBF}" type="datetimeFigureOut">
              <a:rPr lang="en-US" smtClean="0"/>
              <a:pPr/>
              <a:t>12/17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4F01CD-D783-45EB-ADE1-9CD7BB9E85CF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457200" y="1238250"/>
          <a:ext cx="4267200" cy="47053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/>
          <p:cNvSpPr/>
          <p:nvPr/>
        </p:nvSpPr>
        <p:spPr>
          <a:xfrm>
            <a:off x="1143001" y="908051"/>
            <a:ext cx="1265090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100" b="1" dirty="0" smtClean="0">
                <a:latin typeface="Arial" pitchFamily="34" charset="0"/>
                <a:cs typeface="Arial" pitchFamily="34" charset="0"/>
              </a:rPr>
              <a:t>Ontology Terms</a:t>
            </a:r>
            <a:endParaRPr lang="en-US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267713" y="5864353"/>
            <a:ext cx="191430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istribution of GO terms (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5400000">
            <a:off x="3306404" y="1640094"/>
            <a:ext cx="140134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Cellular Component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5400000">
            <a:off x="3328045" y="3020528"/>
            <a:ext cx="13580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Molecular Function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5400000">
            <a:off x="3344075" y="4400962"/>
            <a:ext cx="13260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Biological Process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57200" y="577851"/>
            <a:ext cx="381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A</a:t>
            </a:r>
          </a:p>
        </p:txBody>
      </p:sp>
      <p:graphicFrame>
        <p:nvGraphicFramePr>
          <p:cNvPr id="11" name="Chart 10"/>
          <p:cNvGraphicFramePr/>
          <p:nvPr/>
        </p:nvGraphicFramePr>
        <p:xfrm>
          <a:off x="1066800" y="6400800"/>
          <a:ext cx="2743200" cy="2889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Rectangle 11"/>
          <p:cNvSpPr/>
          <p:nvPr/>
        </p:nvSpPr>
        <p:spPr>
          <a:xfrm>
            <a:off x="1981200" y="9182100"/>
            <a:ext cx="19143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Distribution of GO terms (%)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81000" y="6188026"/>
            <a:ext cx="381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B</a:t>
            </a:r>
          </a:p>
        </p:txBody>
      </p:sp>
      <p:sp>
        <p:nvSpPr>
          <p:cNvPr id="14" name="TextBox 57"/>
          <p:cNvSpPr txBox="1"/>
          <p:nvPr/>
        </p:nvSpPr>
        <p:spPr>
          <a:xfrm>
            <a:off x="152400" y="240268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2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god</dc:creator>
  <cp:lastModifiedBy> </cp:lastModifiedBy>
  <cp:revision>8</cp:revision>
  <dcterms:created xsi:type="dcterms:W3CDTF">2013-04-09T06:30:34Z</dcterms:created>
  <dcterms:modified xsi:type="dcterms:W3CDTF">2013-12-17T04:28:42Z</dcterms:modified>
</cp:coreProperties>
</file>